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61" r:id="rId3"/>
    <p:sldId id="262" r:id="rId4"/>
    <p:sldId id="260" r:id="rId5"/>
    <p:sldId id="257" r:id="rId6"/>
  </p:sldIdLst>
  <p:sldSz cx="6858000" cy="9144000" type="screen4x3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Faiz Kermani" initials="FK" lastIdx="1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064" autoAdjust="0"/>
    <p:restoredTop sz="94660"/>
  </p:normalViewPr>
  <p:slideViewPr>
    <p:cSldViewPr snapToGrid="0">
      <p:cViewPr varScale="1">
        <p:scale>
          <a:sx n="73" d="100"/>
          <a:sy n="73" d="100"/>
        </p:scale>
        <p:origin x="2438" y="77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BA7BB-CC24-4F68-9CDA-3C3EF1090B5D}" type="datetimeFigureOut">
              <a:rPr kumimoji="1" lang="ja-JP" altLang="en-US" smtClean="0"/>
              <a:t>2017/10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EC281-3CDD-4C75-B446-30B3CEE1F3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04072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BA7BB-CC24-4F68-9CDA-3C3EF1090B5D}" type="datetimeFigureOut">
              <a:rPr kumimoji="1" lang="ja-JP" altLang="en-US" smtClean="0"/>
              <a:t>2017/10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EC281-3CDD-4C75-B446-30B3CEE1F3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12293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BA7BB-CC24-4F68-9CDA-3C3EF1090B5D}" type="datetimeFigureOut">
              <a:rPr kumimoji="1" lang="ja-JP" altLang="en-US" smtClean="0"/>
              <a:t>2017/10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EC281-3CDD-4C75-B446-30B3CEE1F3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13302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BA7BB-CC24-4F68-9CDA-3C3EF1090B5D}" type="datetimeFigureOut">
              <a:rPr kumimoji="1" lang="ja-JP" altLang="en-US" smtClean="0"/>
              <a:t>2017/10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EC281-3CDD-4C75-B446-30B3CEE1F3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8840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BA7BB-CC24-4F68-9CDA-3C3EF1090B5D}" type="datetimeFigureOut">
              <a:rPr kumimoji="1" lang="ja-JP" altLang="en-US" smtClean="0"/>
              <a:t>2017/10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EC281-3CDD-4C75-B446-30B3CEE1F3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82558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BA7BB-CC24-4F68-9CDA-3C3EF1090B5D}" type="datetimeFigureOut">
              <a:rPr kumimoji="1" lang="ja-JP" altLang="en-US" smtClean="0"/>
              <a:t>2017/10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EC281-3CDD-4C75-B446-30B3CEE1F3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58508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BA7BB-CC24-4F68-9CDA-3C3EF1090B5D}" type="datetimeFigureOut">
              <a:rPr kumimoji="1" lang="ja-JP" altLang="en-US" smtClean="0"/>
              <a:t>2017/10/3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EC281-3CDD-4C75-B446-30B3CEE1F3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52229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BA7BB-CC24-4F68-9CDA-3C3EF1090B5D}" type="datetimeFigureOut">
              <a:rPr kumimoji="1" lang="ja-JP" altLang="en-US" smtClean="0"/>
              <a:t>2017/10/3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EC281-3CDD-4C75-B446-30B3CEE1F3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2393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BA7BB-CC24-4F68-9CDA-3C3EF1090B5D}" type="datetimeFigureOut">
              <a:rPr kumimoji="1" lang="ja-JP" altLang="en-US" smtClean="0"/>
              <a:t>2017/10/3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EC281-3CDD-4C75-B446-30B3CEE1F3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56783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BA7BB-CC24-4F68-9CDA-3C3EF1090B5D}" type="datetimeFigureOut">
              <a:rPr kumimoji="1" lang="ja-JP" altLang="en-US" smtClean="0"/>
              <a:t>2017/10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EC281-3CDD-4C75-B446-30B3CEE1F3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41496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BA7BB-CC24-4F68-9CDA-3C3EF1090B5D}" type="datetimeFigureOut">
              <a:rPr kumimoji="1" lang="ja-JP" altLang="en-US" smtClean="0"/>
              <a:t>2017/10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EC281-3CDD-4C75-B446-30B3CEE1F3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35728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CBA7BB-CC24-4F68-9CDA-3C3EF1090B5D}" type="datetimeFigureOut">
              <a:rPr kumimoji="1" lang="ja-JP" altLang="en-US" smtClean="0"/>
              <a:t>2017/10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6EC281-3CDD-4C75-B446-30B3CEE1F3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59091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1718723" y="5456288"/>
            <a:ext cx="362894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. The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echanism of type I allergy.</a:t>
            </a:r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3898" y="508001"/>
            <a:ext cx="5890203" cy="46734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8154273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4821" y="985940"/>
            <a:ext cx="5441950" cy="2970726"/>
          </a:xfrm>
          <a:prstGeom prst="rect">
            <a:avLst/>
          </a:prstGeom>
        </p:spPr>
      </p:pic>
      <p:sp>
        <p:nvSpPr>
          <p:cNvPr id="6" name="正方形/長方形 5"/>
          <p:cNvSpPr/>
          <p:nvPr/>
        </p:nvSpPr>
        <p:spPr>
          <a:xfrm>
            <a:off x="706212" y="4284120"/>
            <a:ext cx="5445576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Figure S2. CI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hanges (ΔCI) of PAM212 cells in response to EGF.</a:t>
            </a:r>
            <a:endParaRPr lang="ja-JP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807816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1059" y="1259036"/>
            <a:ext cx="6135882" cy="29436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正方形/長方形 5"/>
          <p:cNvSpPr/>
          <p:nvPr/>
        </p:nvSpPr>
        <p:spPr>
          <a:xfrm>
            <a:off x="267908" y="4311050"/>
            <a:ext cx="6358670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altLang="ja-JP" sz="14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Effects </a:t>
            </a: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 inhibitors on CI of RBL-2H3 cells</a:t>
            </a:r>
            <a:r>
              <a:rPr lang="ja-JP" alt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ith or without stimulation by DNP-HSA. The gray-bar indicates the presence of each inhibitor, and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bold </a:t>
            </a:r>
            <a:r>
              <a:rPr lang="en-US" altLang="ja-JP" sz="14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lack-bar </a:t>
            </a: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dicates the presence of </a:t>
            </a:r>
            <a:r>
              <a:rPr lang="en-US" altLang="ja-JP" sz="14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NP-HSA.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023488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/>
          <p:cNvSpPr/>
          <p:nvPr/>
        </p:nvSpPr>
        <p:spPr>
          <a:xfrm>
            <a:off x="519290" y="4066411"/>
            <a:ext cx="6005688" cy="6740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defTabSz="685800">
              <a:lnSpc>
                <a:spcPct val="90000"/>
              </a:lnSpc>
              <a:spcBef>
                <a:spcPts val="750"/>
              </a:spcBef>
            </a:pPr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S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altLang="ja-JP" sz="14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Correlation </a:t>
            </a: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 the amount of QR-specific </a:t>
            </a:r>
            <a:r>
              <a:rPr lang="en-US" altLang="ja-JP" sz="14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gE</a:t>
            </a: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 sera of patients detected by the cell-based assay using an impedance sensor and ELISA.</a:t>
            </a:r>
            <a:r>
              <a:rPr lang="ja-JP" alt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ja-JP" sz="14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=0.1847, p=0.1870  </a:t>
            </a:r>
            <a:r>
              <a:rPr lang="en-US" altLang="ja-JP" sz="14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ja-JP" alt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●</a:t>
            </a: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r>
              <a:rPr lang="ja-JP" alt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QR</a:t>
            </a:r>
            <a:r>
              <a:rPr lang="en-US" altLang="ja-JP" sz="14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-), </a:t>
            </a:r>
            <a:r>
              <a:rPr lang="ja-JP" altLang="en-US" sz="14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○</a:t>
            </a: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QR(+))</a:t>
            </a:r>
            <a:endParaRPr lang="ja-JP" altLang="ja-JP" sz="14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21188" y="598093"/>
            <a:ext cx="4815624" cy="33556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75516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コンテンツ プレースホルダー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873" y="1140179"/>
            <a:ext cx="6196253" cy="1788408"/>
          </a:xfrm>
        </p:spPr>
      </p:pic>
      <p:sp>
        <p:nvSpPr>
          <p:cNvPr id="2" name="正方形/長方形 1"/>
          <p:cNvSpPr/>
          <p:nvPr/>
        </p:nvSpPr>
        <p:spPr>
          <a:xfrm>
            <a:off x="522969" y="3395092"/>
            <a:ext cx="5994400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S5. (a) CI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hanges </a:t>
            </a:r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of RBL-48 cells sensitized with </a:t>
            </a:r>
            <a:r>
              <a:rPr lang="en-US" altLang="ja-JP" sz="1400" smtClean="0">
                <a:latin typeface="Arial" panose="020B0604020202020204" pitchFamily="34" charset="0"/>
                <a:cs typeface="Arial" panose="020B0604020202020204" pitchFamily="34" charset="0"/>
              </a:rPr>
              <a:t>serum </a:t>
            </a:r>
            <a:r>
              <a:rPr lang="en-US" altLang="ja-JP" sz="1400" smtClean="0">
                <a:latin typeface="Arial" panose="020B0604020202020204" pitchFamily="34" charset="0"/>
                <a:cs typeface="Arial" panose="020B0604020202020204" pitchFamily="34" charset="0"/>
              </a:rPr>
              <a:t>of a </a:t>
            </a:r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on-responder in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response to </a:t>
            </a:r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nti-IgE.</a:t>
            </a:r>
            <a:r>
              <a:rPr lang="ja-JP" alt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b) Histamine release of basophils from a non-responder in response to anti-IgE. 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304800" y="692666"/>
            <a:ext cx="4363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3516489" y="692666"/>
            <a:ext cx="4363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670842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37</TotalTime>
  <Words>146</Words>
  <Application>Microsoft Office PowerPoint</Application>
  <PresentationFormat>画面に合わせる (4:3)</PresentationFormat>
  <Paragraphs>7</Paragraphs>
  <Slides>5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0" baseType="lpstr">
      <vt:lpstr>ＭＳ Ｐゴシック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Reiko</dc:creator>
  <cp:lastModifiedBy>Reiko</cp:lastModifiedBy>
  <cp:revision>47</cp:revision>
  <cp:lastPrinted>2017-09-21T08:35:32Z</cp:lastPrinted>
  <dcterms:created xsi:type="dcterms:W3CDTF">2017-04-20T08:34:29Z</dcterms:created>
  <dcterms:modified xsi:type="dcterms:W3CDTF">2017-10-31T02:59:07Z</dcterms:modified>
</cp:coreProperties>
</file>